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4BBB66-58CF-3D45-A0FE-F282CBFC0C04}" v="14" dt="2023-08-28T22:11:53.6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458"/>
    <p:restoredTop sz="96327"/>
  </p:normalViewPr>
  <p:slideViewPr>
    <p:cSldViewPr snapToGrid="0">
      <p:cViewPr varScale="1">
        <p:scale>
          <a:sx n="119" d="100"/>
          <a:sy n="119" d="100"/>
        </p:scale>
        <p:origin x="11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, Dan" userId="7f155b1c-ffa3-4891-ad57-0f01ba069c69" providerId="ADAL" clId="{0D4BBB66-58CF-3D45-A0FE-F282CBFC0C04}"/>
    <pc:docChg chg="undo custSel modSld">
      <pc:chgData name="Su, Dan" userId="7f155b1c-ffa3-4891-ad57-0f01ba069c69" providerId="ADAL" clId="{0D4BBB66-58CF-3D45-A0FE-F282CBFC0C04}" dt="2023-08-28T22:12:45.641" v="58" actId="208"/>
      <pc:docMkLst>
        <pc:docMk/>
      </pc:docMkLst>
      <pc:sldChg chg="addSp delSp modSp mod">
        <pc:chgData name="Su, Dan" userId="7f155b1c-ffa3-4891-ad57-0f01ba069c69" providerId="ADAL" clId="{0D4BBB66-58CF-3D45-A0FE-F282CBFC0C04}" dt="2023-08-28T22:12:45.641" v="58" actId="208"/>
        <pc:sldMkLst>
          <pc:docMk/>
          <pc:sldMk cId="255746250" sldId="256"/>
        </pc:sldMkLst>
        <pc:spChg chg="mod">
          <ac:chgData name="Su, Dan" userId="7f155b1c-ffa3-4891-ad57-0f01ba069c69" providerId="ADAL" clId="{0D4BBB66-58CF-3D45-A0FE-F282CBFC0C04}" dt="2023-08-28T22:10:40.071" v="30" actId="207"/>
          <ac:spMkLst>
            <pc:docMk/>
            <pc:sldMk cId="255746250" sldId="256"/>
            <ac:spMk id="44" creationId="{48440E4E-1BD1-C61F-0DDC-574C0168C6CA}"/>
          </ac:spMkLst>
        </pc:spChg>
        <pc:spChg chg="mod">
          <ac:chgData name="Su, Dan" userId="7f155b1c-ffa3-4891-ad57-0f01ba069c69" providerId="ADAL" clId="{0D4BBB66-58CF-3D45-A0FE-F282CBFC0C04}" dt="2023-08-28T22:08:21.544" v="14" actId="207"/>
          <ac:spMkLst>
            <pc:docMk/>
            <pc:sldMk cId="255746250" sldId="256"/>
            <ac:spMk id="45" creationId="{5D40C04B-E0E4-BBCF-A23E-5D7C06476C3C}"/>
          </ac:spMkLst>
        </pc:spChg>
        <pc:spChg chg="mod">
          <ac:chgData name="Su, Dan" userId="7f155b1c-ffa3-4891-ad57-0f01ba069c69" providerId="ADAL" clId="{0D4BBB66-58CF-3D45-A0FE-F282CBFC0C04}" dt="2023-08-28T22:10:35.346" v="29" actId="1076"/>
          <ac:spMkLst>
            <pc:docMk/>
            <pc:sldMk cId="255746250" sldId="256"/>
            <ac:spMk id="46" creationId="{8F9DC8EE-1FFC-91D9-38B2-42CE86107B44}"/>
          </ac:spMkLst>
        </pc:spChg>
        <pc:picChg chg="del">
          <ac:chgData name="Su, Dan" userId="7f155b1c-ffa3-4891-ad57-0f01ba069c69" providerId="ADAL" clId="{0D4BBB66-58CF-3D45-A0FE-F282CBFC0C04}" dt="2023-08-28T22:10:27.404" v="26" actId="478"/>
          <ac:picMkLst>
            <pc:docMk/>
            <pc:sldMk cId="255746250" sldId="256"/>
            <ac:picMk id="2" creationId="{93872DF1-C092-7A9C-3926-71FED8EC42F3}"/>
          </ac:picMkLst>
        </pc:picChg>
        <pc:picChg chg="add del">
          <ac:chgData name="Su, Dan" userId="7f155b1c-ffa3-4891-ad57-0f01ba069c69" providerId="ADAL" clId="{0D4BBB66-58CF-3D45-A0FE-F282CBFC0C04}" dt="2023-08-28T22:08:04.189" v="11" actId="478"/>
          <ac:picMkLst>
            <pc:docMk/>
            <pc:sldMk cId="255746250" sldId="256"/>
            <ac:picMk id="4" creationId="{075509E8-1216-1AFF-EB1E-88E6FF228D02}"/>
          </ac:picMkLst>
        </pc:picChg>
        <pc:picChg chg="del">
          <ac:chgData name="Su, Dan" userId="7f155b1c-ffa3-4891-ad57-0f01ba069c69" providerId="ADAL" clId="{0D4BBB66-58CF-3D45-A0FE-F282CBFC0C04}" dt="2023-08-28T22:09:43.382" v="20" actId="478"/>
          <ac:picMkLst>
            <pc:docMk/>
            <pc:sldMk cId="255746250" sldId="256"/>
            <ac:picMk id="5" creationId="{EE484793-7969-2379-4862-09AB662D4113}"/>
          </ac:picMkLst>
        </pc:picChg>
        <pc:picChg chg="add del mod">
          <ac:chgData name="Su, Dan" userId="7f155b1c-ffa3-4891-ad57-0f01ba069c69" providerId="ADAL" clId="{0D4BBB66-58CF-3D45-A0FE-F282CBFC0C04}" dt="2023-08-28T22:11:58.271" v="48" actId="478"/>
          <ac:picMkLst>
            <pc:docMk/>
            <pc:sldMk cId="255746250" sldId="256"/>
            <ac:picMk id="27" creationId="{AF9C7BB4-60A5-7CA8-C8F3-7FD3EBA5A3F8}"/>
          </ac:picMkLst>
        </pc:picChg>
        <pc:picChg chg="add del mod">
          <ac:chgData name="Su, Dan" userId="7f155b1c-ffa3-4891-ad57-0f01ba069c69" providerId="ADAL" clId="{0D4BBB66-58CF-3D45-A0FE-F282CBFC0C04}" dt="2023-08-28T22:07:25.730" v="4"/>
          <ac:picMkLst>
            <pc:docMk/>
            <pc:sldMk cId="255746250" sldId="256"/>
            <ac:picMk id="57" creationId="{74ED28EF-7066-6009-D511-3F31BBA18833}"/>
          </ac:picMkLst>
        </pc:picChg>
        <pc:picChg chg="add mod">
          <ac:chgData name="Su, Dan" userId="7f155b1c-ffa3-4891-ad57-0f01ba069c69" providerId="ADAL" clId="{0D4BBB66-58CF-3D45-A0FE-F282CBFC0C04}" dt="2023-08-28T22:08:39.621" v="15" actId="208"/>
          <ac:picMkLst>
            <pc:docMk/>
            <pc:sldMk cId="255746250" sldId="256"/>
            <ac:picMk id="74" creationId="{23C8004C-2575-FEE1-33CA-41A645D28E21}"/>
          </ac:picMkLst>
        </pc:picChg>
        <pc:picChg chg="add mod">
          <ac:chgData name="Su, Dan" userId="7f155b1c-ffa3-4891-ad57-0f01ba069c69" providerId="ADAL" clId="{0D4BBB66-58CF-3D45-A0FE-F282CBFC0C04}" dt="2023-08-28T22:09:46.045" v="21" actId="208"/>
          <ac:picMkLst>
            <pc:docMk/>
            <pc:sldMk cId="255746250" sldId="256"/>
            <ac:picMk id="75" creationId="{7490FD4D-A8C0-491A-0B4F-E0FEFEAFAA05}"/>
          </ac:picMkLst>
        </pc:picChg>
        <pc:picChg chg="add mod">
          <ac:chgData name="Su, Dan" userId="7f155b1c-ffa3-4891-ad57-0f01ba069c69" providerId="ADAL" clId="{0D4BBB66-58CF-3D45-A0FE-F282CBFC0C04}" dt="2023-08-28T22:12:45.641" v="58" actId="208"/>
          <ac:picMkLst>
            <pc:docMk/>
            <pc:sldMk cId="255746250" sldId="256"/>
            <ac:picMk id="76" creationId="{FB3BFBF5-4169-09C8-AE26-E13A0AB4FD00}"/>
          </ac:picMkLst>
        </pc:picChg>
        <pc:picChg chg="add del mod">
          <ac:chgData name="Su, Dan" userId="7f155b1c-ffa3-4891-ad57-0f01ba069c69" providerId="ADAL" clId="{0D4BBB66-58CF-3D45-A0FE-F282CBFC0C04}" dt="2023-08-28T22:11:20.237" v="39" actId="478"/>
          <ac:picMkLst>
            <pc:docMk/>
            <pc:sldMk cId="255746250" sldId="256"/>
            <ac:picMk id="77" creationId="{E26F4F2A-80A2-40A5-E401-979EE22B0374}"/>
          </ac:picMkLst>
        </pc:picChg>
        <pc:picChg chg="add del">
          <ac:chgData name="Su, Dan" userId="7f155b1c-ffa3-4891-ad57-0f01ba069c69" providerId="ADAL" clId="{0D4BBB66-58CF-3D45-A0FE-F282CBFC0C04}" dt="2023-08-28T22:11:33.850" v="42"/>
          <ac:picMkLst>
            <pc:docMk/>
            <pc:sldMk cId="255746250" sldId="256"/>
            <ac:picMk id="78" creationId="{32320307-92AF-BACE-CD15-7BF6F11AD50F}"/>
          </ac:picMkLst>
        </pc:picChg>
        <pc:picChg chg="add mod modCrop">
          <ac:chgData name="Su, Dan" userId="7f155b1c-ffa3-4891-ad57-0f01ba069c69" providerId="ADAL" clId="{0D4BBB66-58CF-3D45-A0FE-F282CBFC0C04}" dt="2023-08-28T22:12:40.711" v="57" actId="208"/>
          <ac:picMkLst>
            <pc:docMk/>
            <pc:sldMk cId="255746250" sldId="256"/>
            <ac:picMk id="79" creationId="{AC138714-DB81-8C3A-954E-CED3AB69C389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hIPqPCR710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hIPqPCR7102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17</c:f>
              <c:strCache>
                <c:ptCount val="1"/>
                <c:pt idx="0">
                  <c:v>H3k36me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K$18:$K$19</c:f>
              <c:strCache>
                <c:ptCount val="2"/>
                <c:pt idx="0">
                  <c:v>Whsc1pr Ptx2</c:v>
                </c:pt>
                <c:pt idx="1">
                  <c:v>Whc1pr Cntr</c:v>
                </c:pt>
              </c:strCache>
            </c:strRef>
          </c:cat>
          <c:val>
            <c:numRef>
              <c:f>Sheet2!$L$18:$L$19</c:f>
              <c:numCache>
                <c:formatCode>General</c:formatCode>
                <c:ptCount val="2"/>
                <c:pt idx="0">
                  <c:v>5.1873582186040386</c:v>
                </c:pt>
                <c:pt idx="1">
                  <c:v>1.28342589756290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8D-A04E-B3FF-00398B850D2C}"/>
            </c:ext>
          </c:extLst>
        </c:ser>
        <c:ser>
          <c:idx val="1"/>
          <c:order val="1"/>
          <c:tx>
            <c:strRef>
              <c:f>Sheet2!$M$17</c:f>
              <c:strCache>
                <c:ptCount val="1"/>
                <c:pt idx="0">
                  <c:v>Ig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K$18:$K$19</c:f>
              <c:strCache>
                <c:ptCount val="2"/>
                <c:pt idx="0">
                  <c:v>Whsc1pr Ptx2</c:v>
                </c:pt>
                <c:pt idx="1">
                  <c:v>Whc1pr Cntr</c:v>
                </c:pt>
              </c:strCache>
            </c:strRef>
          </c:cat>
          <c:val>
            <c:numRef>
              <c:f>Sheet2!$M$18:$M$19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68D-A04E-B3FF-00398B850D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0775080"/>
        <c:axId val="430768520"/>
      </c:barChart>
      <c:catAx>
        <c:axId val="4307750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430768520"/>
        <c:crosses val="autoZero"/>
        <c:auto val="1"/>
        <c:lblAlgn val="ctr"/>
        <c:lblOffset val="100"/>
        <c:noMultiLvlLbl val="0"/>
      </c:catAx>
      <c:valAx>
        <c:axId val="4307685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4307750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7201825457254711"/>
          <c:y val="0.12110193445412004"/>
          <c:w val="0.52491136944909966"/>
          <c:h val="0.333024546024919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20</c:f>
              <c:strCache>
                <c:ptCount val="1"/>
                <c:pt idx="0">
                  <c:v>H3k36me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K$21:$K$22</c:f>
              <c:strCache>
                <c:ptCount val="2"/>
                <c:pt idx="0">
                  <c:v>Pitx2pr Pitx2</c:v>
                </c:pt>
                <c:pt idx="1">
                  <c:v>Pitx2pr cntr</c:v>
                </c:pt>
              </c:strCache>
            </c:strRef>
          </c:cat>
          <c:val>
            <c:numRef>
              <c:f>Sheet2!$L$21:$L$22</c:f>
              <c:numCache>
                <c:formatCode>General</c:formatCode>
                <c:ptCount val="2"/>
                <c:pt idx="0">
                  <c:v>6.1261097269473703</c:v>
                </c:pt>
                <c:pt idx="1">
                  <c:v>1.6913397969275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15-9247-9B42-6D9CC07FACE8}"/>
            </c:ext>
          </c:extLst>
        </c:ser>
        <c:ser>
          <c:idx val="1"/>
          <c:order val="1"/>
          <c:tx>
            <c:strRef>
              <c:f>Sheet2!$M$20</c:f>
              <c:strCache>
                <c:ptCount val="1"/>
                <c:pt idx="0">
                  <c:v>Ig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K$21:$K$22</c:f>
              <c:strCache>
                <c:ptCount val="2"/>
                <c:pt idx="0">
                  <c:v>Pitx2pr Pitx2</c:v>
                </c:pt>
                <c:pt idx="1">
                  <c:v>Pitx2pr cntr</c:v>
                </c:pt>
              </c:strCache>
            </c:strRef>
          </c:cat>
          <c:val>
            <c:numRef>
              <c:f>Sheet2!$M$21:$M$22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15-9247-9B42-6D9CC07FAC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4345016"/>
        <c:axId val="624343048"/>
      </c:barChart>
      <c:catAx>
        <c:axId val="6243450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24343048"/>
        <c:crosses val="autoZero"/>
        <c:auto val="1"/>
        <c:lblAlgn val="ctr"/>
        <c:lblOffset val="100"/>
        <c:noMultiLvlLbl val="0"/>
      </c:catAx>
      <c:valAx>
        <c:axId val="624343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6243450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6530185021344896"/>
          <c:y val="0.10532852402990718"/>
          <c:w val="0.52727554014919675"/>
          <c:h val="0.302542018753485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123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977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93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695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372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05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690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934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058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857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435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FD984-0F86-7F4C-9535-855F40CABDF7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B7E26-F2AB-6840-A587-05826F33A6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971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tiff"/><Relationship Id="rId3" Type="http://schemas.microsoft.com/office/2007/relationships/hdphoto" Target="../media/hdphoto1.wdp"/><Relationship Id="rId7" Type="http://schemas.openxmlformats.org/officeDocument/2006/relationships/chart" Target="../charts/chart2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74">
            <a:extLst>
              <a:ext uri="{FF2B5EF4-FFF2-40B4-BE49-F238E27FC236}">
                <a16:creationId xmlns:a16="http://schemas.microsoft.com/office/drawing/2014/main" id="{7490FD4D-A8C0-491A-0B4F-E0FEFEAFAA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3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7808" y="2389849"/>
            <a:ext cx="1975245" cy="10129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23C8004C-2575-FEE1-33CA-41A645D28E2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3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01274" y="1224582"/>
            <a:ext cx="1976951" cy="10783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3D0D56A1-701B-EAF6-533E-D800472693CE}"/>
              </a:ext>
            </a:extLst>
          </p:cNvPr>
          <p:cNvSpPr txBox="1"/>
          <p:nvPr/>
        </p:nvSpPr>
        <p:spPr>
          <a:xfrm>
            <a:off x="6415693" y="143226"/>
            <a:ext cx="17411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Helvetica" pitchFamily="2" charset="0"/>
              </a:rPr>
              <a:t>Su</a:t>
            </a:r>
            <a:r>
              <a:rPr lang="en-US" sz="1200" dirty="0">
                <a:latin typeface="Helvetica" pitchFamily="2" charset="0"/>
              </a:rPr>
              <a:t> et al., Suppl. Fig. 2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C6BA7F-BD62-8606-D30A-23DC15E9841D}"/>
              </a:ext>
            </a:extLst>
          </p:cNvPr>
          <p:cNvSpPr txBox="1"/>
          <p:nvPr/>
        </p:nvSpPr>
        <p:spPr>
          <a:xfrm>
            <a:off x="2732843" y="1376203"/>
            <a:ext cx="78123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300bp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A166B40-4D22-CABB-B41C-BF07915B4B12}"/>
              </a:ext>
            </a:extLst>
          </p:cNvPr>
          <p:cNvCxnSpPr>
            <a:cxnSpLocks/>
          </p:cNvCxnSpPr>
          <p:nvPr/>
        </p:nvCxnSpPr>
        <p:spPr>
          <a:xfrm>
            <a:off x="3363881" y="1541657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4F99BDF-A547-4C07-D66E-791EA906A8AB}"/>
              </a:ext>
            </a:extLst>
          </p:cNvPr>
          <p:cNvCxnSpPr>
            <a:cxnSpLocks/>
          </p:cNvCxnSpPr>
          <p:nvPr/>
        </p:nvCxnSpPr>
        <p:spPr>
          <a:xfrm>
            <a:off x="3365361" y="1836100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9AF054A-377F-E9D0-B439-AB6A6BCC1A61}"/>
              </a:ext>
            </a:extLst>
          </p:cNvPr>
          <p:cNvCxnSpPr>
            <a:cxnSpLocks/>
          </p:cNvCxnSpPr>
          <p:nvPr/>
        </p:nvCxnSpPr>
        <p:spPr>
          <a:xfrm>
            <a:off x="3366841" y="2228197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056ADFD2-F856-B8B2-4A0E-7DE6AA253439}"/>
              </a:ext>
            </a:extLst>
          </p:cNvPr>
          <p:cNvSpPr txBox="1"/>
          <p:nvPr/>
        </p:nvSpPr>
        <p:spPr>
          <a:xfrm>
            <a:off x="2741722" y="1688400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200b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23D4C64-66CA-53C4-01C1-C6D7DE9CC2E5}"/>
              </a:ext>
            </a:extLst>
          </p:cNvPr>
          <p:cNvSpPr txBox="1"/>
          <p:nvPr/>
        </p:nvSpPr>
        <p:spPr>
          <a:xfrm>
            <a:off x="2741720" y="2061263"/>
            <a:ext cx="77383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100bp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D941988-DC04-006F-893E-A5E4DA5B819D}"/>
              </a:ext>
            </a:extLst>
          </p:cNvPr>
          <p:cNvCxnSpPr>
            <a:cxnSpLocks/>
          </p:cNvCxnSpPr>
          <p:nvPr/>
        </p:nvCxnSpPr>
        <p:spPr>
          <a:xfrm>
            <a:off x="3339122" y="3286118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17F7BECB-15A3-0FB8-8EB2-16B07BA4301A}"/>
              </a:ext>
            </a:extLst>
          </p:cNvPr>
          <p:cNvCxnSpPr>
            <a:cxnSpLocks/>
          </p:cNvCxnSpPr>
          <p:nvPr/>
        </p:nvCxnSpPr>
        <p:spPr>
          <a:xfrm>
            <a:off x="3352044" y="2914736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9361231-4EEB-ACBC-743C-928C15FFE318}"/>
              </a:ext>
            </a:extLst>
          </p:cNvPr>
          <p:cNvSpPr txBox="1"/>
          <p:nvPr/>
        </p:nvSpPr>
        <p:spPr>
          <a:xfrm>
            <a:off x="2734324" y="2746322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200b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6A33E5-BC89-5140-55F0-4C087B017CBC}"/>
              </a:ext>
            </a:extLst>
          </p:cNvPr>
          <p:cNvSpPr txBox="1"/>
          <p:nvPr/>
        </p:nvSpPr>
        <p:spPr>
          <a:xfrm>
            <a:off x="2743202" y="3119184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100b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9E61AE9-555B-734E-FD57-624DA98F677C}"/>
              </a:ext>
            </a:extLst>
          </p:cNvPr>
          <p:cNvSpPr txBox="1"/>
          <p:nvPr/>
        </p:nvSpPr>
        <p:spPr>
          <a:xfrm>
            <a:off x="2011680" y="855019"/>
            <a:ext cx="1756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latin typeface="Helvetica" pitchFamily="2" charset="0"/>
              </a:rPr>
              <a:t>Whsc1 </a:t>
            </a:r>
            <a:r>
              <a:rPr lang="en-US" sz="1200" b="1" dirty="0">
                <a:latin typeface="Helvetica" pitchFamily="2" charset="0"/>
              </a:rPr>
              <a:t>promote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E9560D1-C682-C67E-8FD8-2D898C85F49B}"/>
              </a:ext>
            </a:extLst>
          </p:cNvPr>
          <p:cNvSpPr txBox="1"/>
          <p:nvPr/>
        </p:nvSpPr>
        <p:spPr>
          <a:xfrm>
            <a:off x="2615362" y="2393715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Control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33D64D2-9E4A-F552-4B6F-F4F680B34961}"/>
              </a:ext>
            </a:extLst>
          </p:cNvPr>
          <p:cNvSpPr txBox="1"/>
          <p:nvPr/>
        </p:nvSpPr>
        <p:spPr>
          <a:xfrm rot="18900000">
            <a:off x="5121420" y="862256"/>
            <a:ext cx="7056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E38C0D2-597D-D44C-A389-1A8F54B85449}"/>
              </a:ext>
            </a:extLst>
          </p:cNvPr>
          <p:cNvSpPr txBox="1"/>
          <p:nvPr/>
        </p:nvSpPr>
        <p:spPr>
          <a:xfrm rot="18900000">
            <a:off x="4698458" y="655060"/>
            <a:ext cx="133541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No Ab 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89853E-87CD-F436-AC8F-8280F0809AA8}"/>
              </a:ext>
            </a:extLst>
          </p:cNvPr>
          <p:cNvSpPr txBox="1"/>
          <p:nvPr/>
        </p:nvSpPr>
        <p:spPr>
          <a:xfrm rot="18900000">
            <a:off x="4406571" y="685621"/>
            <a:ext cx="121773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IgG 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EE9C7BE-B61F-EFD4-3A4C-E43E2D9A094C}"/>
              </a:ext>
            </a:extLst>
          </p:cNvPr>
          <p:cNvSpPr txBox="1"/>
          <p:nvPr/>
        </p:nvSpPr>
        <p:spPr>
          <a:xfrm rot="18900000">
            <a:off x="4032900" y="601467"/>
            <a:ext cx="148045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hIP-H3K36me2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5BCF6F5-7D2C-3AD2-BF8B-CCAFF5B190E6}"/>
              </a:ext>
            </a:extLst>
          </p:cNvPr>
          <p:cNvSpPr txBox="1"/>
          <p:nvPr/>
        </p:nvSpPr>
        <p:spPr>
          <a:xfrm rot="18900000">
            <a:off x="3726603" y="691294"/>
            <a:ext cx="12215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PCR control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C34C9780-80CE-0452-675F-5BA676C1CE34}"/>
              </a:ext>
            </a:extLst>
          </p:cNvPr>
          <p:cNvGrpSpPr/>
          <p:nvPr/>
        </p:nvGrpSpPr>
        <p:grpSpPr>
          <a:xfrm>
            <a:off x="5676670" y="1453993"/>
            <a:ext cx="2314474" cy="1636940"/>
            <a:chOff x="4914670" y="1453993"/>
            <a:chExt cx="2314474" cy="1636940"/>
          </a:xfrm>
        </p:grpSpPr>
        <p:graphicFrame>
          <p:nvGraphicFramePr>
            <p:cNvPr id="28" name="Chart 27">
              <a:extLst>
                <a:ext uri="{FF2B5EF4-FFF2-40B4-BE49-F238E27FC236}">
                  <a16:creationId xmlns:a16="http://schemas.microsoft.com/office/drawing/2014/main" id="{63D98DEB-C431-7315-CEB1-E175D387222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99701190"/>
                </p:ext>
              </p:extLst>
            </p:nvPr>
          </p:nvGraphicFramePr>
          <p:xfrm>
            <a:off x="5130942" y="1477379"/>
            <a:ext cx="2077726" cy="15587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662989D-8A1A-9C1D-42CC-93C28F65E311}"/>
                </a:ext>
              </a:extLst>
            </p:cNvPr>
            <p:cNvSpPr txBox="1"/>
            <p:nvPr/>
          </p:nvSpPr>
          <p:spPr>
            <a:xfrm rot="16200000">
              <a:off x="4397997" y="1970666"/>
              <a:ext cx="1310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Fold enrichmen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881FDF8-0C2E-F388-231B-4F50983E4EEA}"/>
                </a:ext>
              </a:extLst>
            </p:cNvPr>
            <p:cNvSpPr txBox="1"/>
            <p:nvPr/>
          </p:nvSpPr>
          <p:spPr>
            <a:xfrm>
              <a:off x="5282214" y="2627789"/>
              <a:ext cx="103105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i="1" dirty="0">
                  <a:latin typeface="Helvetica" pitchFamily="2" charset="0"/>
                </a:rPr>
                <a:t>Whsc1 </a:t>
              </a:r>
              <a:r>
                <a:rPr lang="en-US" sz="1200" b="1" dirty="0">
                  <a:latin typeface="Helvetica" pitchFamily="2" charset="0"/>
                </a:rPr>
                <a:t>Pro-</a:t>
              </a:r>
            </a:p>
            <a:p>
              <a:pPr algn="ctr"/>
              <a:r>
                <a:rPr lang="en-US" sz="1200" b="1" dirty="0">
                  <a:latin typeface="Helvetica" pitchFamily="2" charset="0"/>
                </a:rPr>
                <a:t>Pitx2 sit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F84B3B6-AC68-B507-B09B-CF6ABA38FB12}"/>
                </a:ext>
              </a:extLst>
            </p:cNvPr>
            <p:cNvSpPr txBox="1"/>
            <p:nvPr/>
          </p:nvSpPr>
          <p:spPr>
            <a:xfrm>
              <a:off x="6198093" y="2629268"/>
              <a:ext cx="103105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i="1" dirty="0">
                  <a:latin typeface="Helvetica" pitchFamily="2" charset="0"/>
                </a:rPr>
                <a:t>Whsc1 </a:t>
              </a:r>
              <a:r>
                <a:rPr lang="en-US" sz="1200" b="1" dirty="0">
                  <a:latin typeface="Helvetica" pitchFamily="2" charset="0"/>
                </a:rPr>
                <a:t>Pro-</a:t>
              </a:r>
            </a:p>
            <a:p>
              <a:pPr algn="ctr"/>
              <a:r>
                <a:rPr lang="en-US" sz="1200" b="1" dirty="0">
                  <a:latin typeface="Helvetica" pitchFamily="2" charset="0"/>
                </a:rPr>
                <a:t>Control</a:t>
              </a: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5D40C04B-E0E4-BBCF-A23E-5D7C06476C3C}"/>
              </a:ext>
            </a:extLst>
          </p:cNvPr>
          <p:cNvSpPr txBox="1"/>
          <p:nvPr/>
        </p:nvSpPr>
        <p:spPr>
          <a:xfrm>
            <a:off x="4052236" y="151918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B0B619E-5777-79D0-07CF-B4CBE91A7931}"/>
              </a:ext>
            </a:extLst>
          </p:cNvPr>
          <p:cNvSpPr txBox="1"/>
          <p:nvPr/>
        </p:nvSpPr>
        <p:spPr>
          <a:xfrm>
            <a:off x="606926" y="392498"/>
            <a:ext cx="332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A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A12094-6807-C6DC-FB56-E977066BF5B5}"/>
              </a:ext>
            </a:extLst>
          </p:cNvPr>
          <p:cNvSpPr txBox="1"/>
          <p:nvPr/>
        </p:nvSpPr>
        <p:spPr>
          <a:xfrm rot="18900000">
            <a:off x="3934456" y="4031003"/>
            <a:ext cx="14418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hIP-H3K36me2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FB645944-D4DD-2111-6191-720C172EA2BA}"/>
              </a:ext>
            </a:extLst>
          </p:cNvPr>
          <p:cNvCxnSpPr>
            <a:cxnSpLocks/>
          </p:cNvCxnSpPr>
          <p:nvPr/>
        </p:nvCxnSpPr>
        <p:spPr>
          <a:xfrm>
            <a:off x="3390083" y="4788299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B1A375D6-5C11-086F-45C2-F37F4A7763C0}"/>
              </a:ext>
            </a:extLst>
          </p:cNvPr>
          <p:cNvSpPr txBox="1"/>
          <p:nvPr/>
        </p:nvSpPr>
        <p:spPr>
          <a:xfrm rot="18900000">
            <a:off x="4779469" y="4257835"/>
            <a:ext cx="7056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5EAAAC7-1973-E7CB-AEA5-6FB3479C7B76}"/>
              </a:ext>
            </a:extLst>
          </p:cNvPr>
          <p:cNvSpPr txBox="1"/>
          <p:nvPr/>
        </p:nvSpPr>
        <p:spPr>
          <a:xfrm rot="18900000">
            <a:off x="4449722" y="4069357"/>
            <a:ext cx="12824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No Ab 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09654B3-49D4-3CFB-EC1B-BCF970806E0D}"/>
              </a:ext>
            </a:extLst>
          </p:cNvPr>
          <p:cNvSpPr txBox="1"/>
          <p:nvPr/>
        </p:nvSpPr>
        <p:spPr>
          <a:xfrm rot="18900000">
            <a:off x="4267122" y="4128572"/>
            <a:ext cx="108374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IgG 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922FE77-36F2-ED57-B5F4-B6449C049A38}"/>
              </a:ext>
            </a:extLst>
          </p:cNvPr>
          <p:cNvSpPr txBox="1"/>
          <p:nvPr/>
        </p:nvSpPr>
        <p:spPr>
          <a:xfrm rot="18900000">
            <a:off x="3720532" y="4085678"/>
            <a:ext cx="12215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PCR control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E5932B1-DA97-A3F1-BE29-94D9D6A70B24}"/>
              </a:ext>
            </a:extLst>
          </p:cNvPr>
          <p:cNvCxnSpPr>
            <a:cxnSpLocks/>
          </p:cNvCxnSpPr>
          <p:nvPr/>
        </p:nvCxnSpPr>
        <p:spPr>
          <a:xfrm>
            <a:off x="3388478" y="5022796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C43C5337-12C9-7C4B-BCF6-CC25DD4067B2}"/>
              </a:ext>
            </a:extLst>
          </p:cNvPr>
          <p:cNvCxnSpPr>
            <a:cxnSpLocks/>
          </p:cNvCxnSpPr>
          <p:nvPr/>
        </p:nvCxnSpPr>
        <p:spPr>
          <a:xfrm>
            <a:off x="3359603" y="5629187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3B68F1F8-1A75-3260-AF5A-6937188B03DF}"/>
              </a:ext>
            </a:extLst>
          </p:cNvPr>
          <p:cNvCxnSpPr>
            <a:cxnSpLocks/>
          </p:cNvCxnSpPr>
          <p:nvPr/>
        </p:nvCxnSpPr>
        <p:spPr>
          <a:xfrm>
            <a:off x="3359602" y="5795081"/>
            <a:ext cx="22687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77D6CA25-CE00-FF03-35D9-D7BAAFA5BA0D}"/>
              </a:ext>
            </a:extLst>
          </p:cNvPr>
          <p:cNvSpPr txBox="1"/>
          <p:nvPr/>
        </p:nvSpPr>
        <p:spPr>
          <a:xfrm>
            <a:off x="2712399" y="5468667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200bp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5F5CB08-4C66-3185-120A-F4F102EE4F17}"/>
              </a:ext>
            </a:extLst>
          </p:cNvPr>
          <p:cNvSpPr txBox="1"/>
          <p:nvPr/>
        </p:nvSpPr>
        <p:spPr>
          <a:xfrm>
            <a:off x="2711652" y="5663180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100bp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6E21A74-5F4A-D51C-5684-71A71D71886D}"/>
              </a:ext>
            </a:extLst>
          </p:cNvPr>
          <p:cNvSpPr txBox="1"/>
          <p:nvPr/>
        </p:nvSpPr>
        <p:spPr>
          <a:xfrm>
            <a:off x="2760525" y="4636931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200bp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F86D0F3-38B6-A8A7-F1D0-36C43EA40804}"/>
              </a:ext>
            </a:extLst>
          </p:cNvPr>
          <p:cNvSpPr txBox="1"/>
          <p:nvPr/>
        </p:nvSpPr>
        <p:spPr>
          <a:xfrm>
            <a:off x="2750153" y="4859753"/>
            <a:ext cx="7560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100bp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F9DC8EE-1FFC-91D9-38B2-42CE86107B44}"/>
              </a:ext>
            </a:extLst>
          </p:cNvPr>
          <p:cNvSpPr txBox="1"/>
          <p:nvPr/>
        </p:nvSpPr>
        <p:spPr>
          <a:xfrm>
            <a:off x="2194561" y="4232953"/>
            <a:ext cx="1523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latin typeface="Helvetica" pitchFamily="2" charset="0"/>
              </a:rPr>
              <a:t>Pitx2  </a:t>
            </a:r>
            <a:r>
              <a:rPr lang="en-US" sz="1200" b="1" dirty="0">
                <a:latin typeface="Helvetica" pitchFamily="2" charset="0"/>
              </a:rPr>
              <a:t>promoter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D069A9B-647B-1454-F6EC-0962E0905B23}"/>
              </a:ext>
            </a:extLst>
          </p:cNvPr>
          <p:cNvSpPr txBox="1"/>
          <p:nvPr/>
        </p:nvSpPr>
        <p:spPr>
          <a:xfrm>
            <a:off x="2585985" y="5223661"/>
            <a:ext cx="7761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Control 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60FF269E-D363-A96E-110D-0686CDA58444}"/>
              </a:ext>
            </a:extLst>
          </p:cNvPr>
          <p:cNvGrpSpPr/>
          <p:nvPr/>
        </p:nvGrpSpPr>
        <p:grpSpPr>
          <a:xfrm>
            <a:off x="5808750" y="4398745"/>
            <a:ext cx="2277006" cy="1722545"/>
            <a:chOff x="5067070" y="4177363"/>
            <a:chExt cx="2277006" cy="1722545"/>
          </a:xfrm>
        </p:grpSpPr>
        <p:graphicFrame>
          <p:nvGraphicFramePr>
            <p:cNvPr id="52" name="Chart 51">
              <a:extLst>
                <a:ext uri="{FF2B5EF4-FFF2-40B4-BE49-F238E27FC236}">
                  <a16:creationId xmlns:a16="http://schemas.microsoft.com/office/drawing/2014/main" id="{09EA9DF9-B94C-7560-6F66-D1FCC777900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17839350"/>
                </p:ext>
              </p:extLst>
            </p:nvPr>
          </p:nvGraphicFramePr>
          <p:xfrm>
            <a:off x="5275666" y="4177363"/>
            <a:ext cx="2068410" cy="17158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F9F58DD-FEA5-765E-01CB-53684481C047}"/>
                </a:ext>
              </a:extLst>
            </p:cNvPr>
            <p:cNvSpPr txBox="1"/>
            <p:nvPr/>
          </p:nvSpPr>
          <p:spPr>
            <a:xfrm rot="16200000">
              <a:off x="4550397" y="4779641"/>
              <a:ext cx="1310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</a:rPr>
                <a:t>Fold enrichment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3FB3C9D-3767-6AF9-27EE-408985C2CEB1}"/>
                </a:ext>
              </a:extLst>
            </p:cNvPr>
            <p:cNvSpPr txBox="1"/>
            <p:nvPr/>
          </p:nvSpPr>
          <p:spPr>
            <a:xfrm>
              <a:off x="5498733" y="5436764"/>
              <a:ext cx="9028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i="1" dirty="0">
                  <a:latin typeface="Helvetica" pitchFamily="2" charset="0"/>
                </a:rPr>
                <a:t>Pitx2</a:t>
              </a:r>
              <a:r>
                <a:rPr lang="en-US" sz="1200" b="1" dirty="0">
                  <a:latin typeface="Helvetica" pitchFamily="2" charset="0"/>
                </a:rPr>
                <a:t> Pro-</a:t>
              </a:r>
            </a:p>
            <a:p>
              <a:pPr algn="ctr"/>
              <a:r>
                <a:rPr lang="en-US" sz="1200" b="1" dirty="0">
                  <a:latin typeface="Helvetica" pitchFamily="2" charset="0"/>
                </a:rPr>
                <a:t>Pitx2 site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4A52EE7-ABB1-F327-363A-A96D2FB784C4}"/>
                </a:ext>
              </a:extLst>
            </p:cNvPr>
            <p:cNvSpPr txBox="1"/>
            <p:nvPr/>
          </p:nvSpPr>
          <p:spPr>
            <a:xfrm>
              <a:off x="6414611" y="5438243"/>
              <a:ext cx="9028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i="1" dirty="0">
                  <a:latin typeface="Helvetica" pitchFamily="2" charset="0"/>
                </a:rPr>
                <a:t>Pitx2</a:t>
              </a:r>
              <a:r>
                <a:rPr lang="en-US" sz="1200" b="1" dirty="0">
                  <a:latin typeface="Helvetica" pitchFamily="2" charset="0"/>
                </a:rPr>
                <a:t> Pro-</a:t>
              </a:r>
            </a:p>
            <a:p>
              <a:pPr algn="ctr"/>
              <a:r>
                <a:rPr lang="en-US" sz="1200" b="1" dirty="0">
                  <a:latin typeface="Helvetica" pitchFamily="2" charset="0"/>
                </a:rPr>
                <a:t>Control</a:t>
              </a:r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16301072-FA93-3BCF-2C6C-AD69E80A0AB7}"/>
              </a:ext>
            </a:extLst>
          </p:cNvPr>
          <p:cNvSpPr txBox="1"/>
          <p:nvPr/>
        </p:nvSpPr>
        <p:spPr>
          <a:xfrm>
            <a:off x="717617" y="374690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B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0CBA0896-4CBF-4495-E9BF-7ACB8398B1AF}"/>
              </a:ext>
            </a:extLst>
          </p:cNvPr>
          <p:cNvGrpSpPr/>
          <p:nvPr/>
        </p:nvGrpSpPr>
        <p:grpSpPr>
          <a:xfrm>
            <a:off x="694076" y="1648549"/>
            <a:ext cx="1869709" cy="924902"/>
            <a:chOff x="2058056" y="6930364"/>
            <a:chExt cx="1869709" cy="924902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D7FA697-18FA-43A6-503A-F72C43BB9015}"/>
                </a:ext>
              </a:extLst>
            </p:cNvPr>
            <p:cNvSpPr txBox="1"/>
            <p:nvPr/>
          </p:nvSpPr>
          <p:spPr>
            <a:xfrm>
              <a:off x="2140526" y="7578267"/>
              <a:ext cx="11146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i="1" dirty="0">
                  <a:latin typeface="Helvetica" pitchFamily="2" charset="0"/>
                  <a:cs typeface="Helvetica" panose="020B0604020202020204" pitchFamily="34" charset="0"/>
                </a:rPr>
                <a:t> Whsc1</a:t>
              </a:r>
              <a:r>
                <a:rPr lang="en-US" sz="1200" dirty="0">
                  <a:latin typeface="Helvetica" pitchFamily="2" charset="0"/>
                  <a:cs typeface="Helvetica" panose="020B0604020202020204" pitchFamily="34" charset="0"/>
                </a:rPr>
                <a:t> pro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3F5C0917-C288-B8B0-265A-7B327CA25812}"/>
                </a:ext>
              </a:extLst>
            </p:cNvPr>
            <p:cNvSpPr/>
            <p:nvPr/>
          </p:nvSpPr>
          <p:spPr>
            <a:xfrm>
              <a:off x="3275582" y="7479272"/>
              <a:ext cx="652183" cy="2135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Helvetica" pitchFamily="2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3F998A3-378A-CAEB-7255-F61D4256F44A}"/>
                </a:ext>
              </a:extLst>
            </p:cNvPr>
            <p:cNvSpPr txBox="1"/>
            <p:nvPr/>
          </p:nvSpPr>
          <p:spPr>
            <a:xfrm>
              <a:off x="3230643" y="7449150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 panose="020B0604020202020204" pitchFamily="34" charset="0"/>
                </a:rPr>
                <a:t>Exon 1</a:t>
              </a: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CF9ED773-E9BE-7D86-EFF7-AE80497D7369}"/>
                </a:ext>
              </a:extLst>
            </p:cNvPr>
            <p:cNvCxnSpPr/>
            <p:nvPr/>
          </p:nvCxnSpPr>
          <p:spPr>
            <a:xfrm>
              <a:off x="2457414" y="7477195"/>
              <a:ext cx="0" cy="9967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36634D7-CF37-CCC8-4881-22D5F3082F0A}"/>
                </a:ext>
              </a:extLst>
            </p:cNvPr>
            <p:cNvSpPr txBox="1"/>
            <p:nvPr/>
          </p:nvSpPr>
          <p:spPr>
            <a:xfrm>
              <a:off x="2350400" y="7207225"/>
              <a:ext cx="3096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Helvetica" pitchFamily="2" charset="0"/>
                </a:rPr>
                <a:t>#</a:t>
              </a:r>
              <a:endParaRPr lang="en-US" sz="1200" dirty="0">
                <a:latin typeface="Helvetica" pitchFamily="2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B3885B25-D9F4-085B-D21E-31EF142D0557}"/>
                </a:ext>
              </a:extLst>
            </p:cNvPr>
            <p:cNvCxnSpPr>
              <a:cxnSpLocks/>
            </p:cNvCxnSpPr>
            <p:nvPr/>
          </p:nvCxnSpPr>
          <p:spPr>
            <a:xfrm>
              <a:off x="2147908" y="7586023"/>
              <a:ext cx="112247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A5D0B32-0186-ECDD-FF58-A376BDC9B237}"/>
                </a:ext>
              </a:extLst>
            </p:cNvPr>
            <p:cNvSpPr txBox="1"/>
            <p:nvPr/>
          </p:nvSpPr>
          <p:spPr>
            <a:xfrm>
              <a:off x="2058056" y="6930364"/>
              <a:ext cx="7890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bg1">
                      <a:lumMod val="50000"/>
                    </a:schemeClr>
                  </a:solidFill>
                  <a:latin typeface="Helvetica" pitchFamily="2" charset="0"/>
                  <a:cs typeface="Helvetica" panose="020B0604020202020204" pitchFamily="34" charset="0"/>
                </a:rPr>
                <a:t>control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BBC16CEA-A8BE-9F6D-1D45-CB6ACC4E9FE5}"/>
                </a:ext>
              </a:extLst>
            </p:cNvPr>
            <p:cNvCxnSpPr>
              <a:cxnSpLocks/>
            </p:cNvCxnSpPr>
            <p:nvPr/>
          </p:nvCxnSpPr>
          <p:spPr>
            <a:xfrm>
              <a:off x="2307941" y="7200417"/>
              <a:ext cx="0" cy="371140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36EC240-39E6-C218-567E-172C79350977}"/>
                </a:ext>
              </a:extLst>
            </p:cNvPr>
            <p:cNvSpPr txBox="1"/>
            <p:nvPr/>
          </p:nvSpPr>
          <p:spPr>
            <a:xfrm>
              <a:off x="2476231" y="7200274"/>
              <a:ext cx="7553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Helvetica" panose="020B0604020202020204" pitchFamily="34" charset="0"/>
                </a:rPr>
                <a:t>-2.7</a:t>
              </a:r>
              <a:r>
                <a:rPr lang="zh-CN" altLang="en-US" sz="1200" dirty="0">
                  <a:latin typeface="Helvetica" pitchFamily="2" charset="0"/>
                  <a:cs typeface="Helvetica" panose="020B0604020202020204" pitchFamily="34" charset="0"/>
                </a:rPr>
                <a:t> </a:t>
              </a:r>
              <a:r>
                <a:rPr lang="en-US" sz="1200" dirty="0" err="1">
                  <a:latin typeface="Helvetica" pitchFamily="2" charset="0"/>
                  <a:cs typeface="Helvetica" panose="020B0604020202020204" pitchFamily="34" charset="0"/>
                </a:rPr>
                <a:t>kbp</a:t>
              </a:r>
              <a:endParaRPr lang="en-US" sz="1200" dirty="0">
                <a:latin typeface="Helvetica" pitchFamily="2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039B1221-4D45-96AC-43F1-690276DEBCAB}"/>
              </a:ext>
            </a:extLst>
          </p:cNvPr>
          <p:cNvGrpSpPr/>
          <p:nvPr/>
        </p:nvGrpSpPr>
        <p:grpSpPr>
          <a:xfrm>
            <a:off x="734059" y="4693615"/>
            <a:ext cx="1735283" cy="904776"/>
            <a:chOff x="8614062" y="6958141"/>
            <a:chExt cx="1735283" cy="904776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7D22A0F-4C7A-CD5F-BF76-4563FE26B83A}"/>
                </a:ext>
              </a:extLst>
            </p:cNvPr>
            <p:cNvSpPr txBox="1"/>
            <p:nvPr/>
          </p:nvSpPr>
          <p:spPr>
            <a:xfrm>
              <a:off x="8687978" y="6958141"/>
              <a:ext cx="8820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bg1">
                      <a:lumMod val="50000"/>
                    </a:schemeClr>
                  </a:solidFill>
                  <a:latin typeface="Helvetica" pitchFamily="2" charset="0"/>
                  <a:cs typeface="Helvetica" panose="020B0604020202020204" pitchFamily="34" charset="0"/>
                </a:rPr>
                <a:t>control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4D36F72D-F872-3255-1C0D-5E66A3E0F426}"/>
                </a:ext>
              </a:extLst>
            </p:cNvPr>
            <p:cNvCxnSpPr>
              <a:cxnSpLocks/>
            </p:cNvCxnSpPr>
            <p:nvPr/>
          </p:nvCxnSpPr>
          <p:spPr>
            <a:xfrm>
              <a:off x="9106071" y="7230336"/>
              <a:ext cx="0" cy="354763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88A21B2-E5D4-6DF4-AE32-7C3E4BB3F32E}"/>
                </a:ext>
              </a:extLst>
            </p:cNvPr>
            <p:cNvSpPr txBox="1"/>
            <p:nvPr/>
          </p:nvSpPr>
          <p:spPr>
            <a:xfrm>
              <a:off x="8614062" y="7585918"/>
              <a:ext cx="10360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i="1" dirty="0">
                  <a:latin typeface="Helvetica" pitchFamily="2" charset="0"/>
                  <a:cs typeface="Helvetica" panose="020B0604020202020204" pitchFamily="34" charset="0"/>
                </a:rPr>
                <a:t> Pitx2</a:t>
              </a:r>
              <a:r>
                <a:rPr lang="en-US" sz="1200" dirty="0">
                  <a:latin typeface="Helvetica" pitchFamily="2" charset="0"/>
                  <a:cs typeface="Helvetica" panose="020B0604020202020204" pitchFamily="34" charset="0"/>
                </a:rPr>
                <a:t> pro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2D115279-523D-DD61-3BE1-FCF315CAC948}"/>
                </a:ext>
              </a:extLst>
            </p:cNvPr>
            <p:cNvSpPr/>
            <p:nvPr/>
          </p:nvSpPr>
          <p:spPr>
            <a:xfrm>
              <a:off x="9599922" y="7490831"/>
              <a:ext cx="635123" cy="2040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Helvetica" pitchFamily="2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A38ECF7-DD73-8B79-CF99-937219E32ABD}"/>
                </a:ext>
              </a:extLst>
            </p:cNvPr>
            <p:cNvSpPr txBox="1"/>
            <p:nvPr/>
          </p:nvSpPr>
          <p:spPr>
            <a:xfrm>
              <a:off x="9535251" y="7456338"/>
              <a:ext cx="8140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 panose="020B0604020202020204" pitchFamily="34" charset="0"/>
                </a:rPr>
                <a:t>Exon 1</a:t>
              </a: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9389784C-F038-6659-C74C-477EB17C1D57}"/>
                </a:ext>
              </a:extLst>
            </p:cNvPr>
            <p:cNvCxnSpPr>
              <a:cxnSpLocks/>
            </p:cNvCxnSpPr>
            <p:nvPr/>
          </p:nvCxnSpPr>
          <p:spPr>
            <a:xfrm>
              <a:off x="8713615" y="7592872"/>
              <a:ext cx="88630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7D18046-7112-E464-2896-694EEB74A4CF}"/>
                </a:ext>
              </a:extLst>
            </p:cNvPr>
            <p:cNvSpPr txBox="1"/>
            <p:nvPr/>
          </p:nvSpPr>
          <p:spPr>
            <a:xfrm>
              <a:off x="9233161" y="7203821"/>
              <a:ext cx="794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Helvetica" pitchFamily="2" charset="0"/>
                  <a:cs typeface="Helvetica" panose="020B0604020202020204" pitchFamily="34" charset="0"/>
                </a:rPr>
                <a:t>-1.3</a:t>
              </a:r>
              <a:r>
                <a:rPr lang="zh-CN" altLang="en-US" sz="1200" dirty="0">
                  <a:latin typeface="Helvetica" pitchFamily="2" charset="0"/>
                  <a:cs typeface="Helvetica" panose="020B0604020202020204" pitchFamily="34" charset="0"/>
                </a:rPr>
                <a:t> </a:t>
              </a:r>
              <a:r>
                <a:rPr lang="en-US" sz="1200" dirty="0" err="1">
                  <a:latin typeface="Helvetica" pitchFamily="2" charset="0"/>
                  <a:cs typeface="Helvetica" panose="020B0604020202020204" pitchFamily="34" charset="0"/>
                </a:rPr>
                <a:t>kbp</a:t>
              </a:r>
              <a:endParaRPr lang="en-US" sz="1200" dirty="0">
                <a:latin typeface="Helvetica" pitchFamily="2" charset="0"/>
                <a:cs typeface="Helvetica" panose="020B0604020202020204" pitchFamily="34" charset="0"/>
              </a:endParaRP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58E5A3D9-B211-3A52-EC5E-C21679F0FA79}"/>
                </a:ext>
              </a:extLst>
            </p:cNvPr>
            <p:cNvCxnSpPr/>
            <p:nvPr/>
          </p:nvCxnSpPr>
          <p:spPr>
            <a:xfrm>
              <a:off x="9198311" y="7488845"/>
              <a:ext cx="0" cy="9527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8C7D2D8-42C9-E3A1-D7BD-B4772325623E}"/>
                </a:ext>
              </a:extLst>
            </p:cNvPr>
            <p:cNvSpPr txBox="1"/>
            <p:nvPr/>
          </p:nvSpPr>
          <p:spPr>
            <a:xfrm>
              <a:off x="9097133" y="7212594"/>
              <a:ext cx="2962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US" sz="1200" b="1" dirty="0">
                  <a:solidFill>
                    <a:srgbClr val="000000"/>
                  </a:solidFill>
                  <a:latin typeface="Helvetica" pitchFamily="2" charset="0"/>
                </a:rPr>
                <a:t>#</a:t>
              </a:r>
              <a:endParaRPr lang="en-US" sz="1200" dirty="0">
                <a:latin typeface="Helvetica" pitchFamily="2" charset="0"/>
              </a:endParaRPr>
            </a:p>
          </p:txBody>
        </p:sp>
      </p:grpSp>
      <p:pic>
        <p:nvPicPr>
          <p:cNvPr id="2" name="Content Placeholder 9" descr="A black and white image of a line of circles&#10;&#10;Description automatically generated">
            <a:extLst>
              <a:ext uri="{FF2B5EF4-FFF2-40B4-BE49-F238E27FC236}">
                <a16:creationId xmlns:a16="http://schemas.microsoft.com/office/drawing/2014/main" id="{2DF90241-D830-8C4D-F9EC-B6D90BF9D0B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72716"/>
          <a:stretch/>
        </p:blipFill>
        <p:spPr>
          <a:xfrm>
            <a:off x="3634606" y="4631978"/>
            <a:ext cx="1529066" cy="71019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62F5420-F142-0CCB-E36C-0F170D13B896}"/>
              </a:ext>
            </a:extLst>
          </p:cNvPr>
          <p:cNvSpPr txBox="1"/>
          <p:nvPr/>
        </p:nvSpPr>
        <p:spPr>
          <a:xfrm>
            <a:off x="3905027" y="477639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pic>
        <p:nvPicPr>
          <p:cNvPr id="5" name="Picture 4" descr="A black background with white spots&#10;&#10;Description automatically generated">
            <a:extLst>
              <a:ext uri="{FF2B5EF4-FFF2-40B4-BE49-F238E27FC236}">
                <a16:creationId xmlns:a16="http://schemas.microsoft.com/office/drawing/2014/main" id="{9DDD1D31-CEA6-50B9-3E82-E543642FEFB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73040"/>
          <a:stretch/>
        </p:blipFill>
        <p:spPr>
          <a:xfrm>
            <a:off x="3626446" y="5428044"/>
            <a:ext cx="1547981" cy="6919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746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</TotalTime>
  <Words>84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7</cp:revision>
  <dcterms:created xsi:type="dcterms:W3CDTF">2023-08-10T18:33:12Z</dcterms:created>
  <dcterms:modified xsi:type="dcterms:W3CDTF">2023-10-03T19:52:55Z</dcterms:modified>
</cp:coreProperties>
</file>